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134806770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一樹 野田" initials="一野" lastIdx="2" clrIdx="0">
    <p:extLst>
      <p:ext uri="{19B8F6BF-5375-455C-9EA6-DF929625EA0E}">
        <p15:presenceInfo xmlns:p15="http://schemas.microsoft.com/office/powerpoint/2012/main" userId="17b979a6b5b904d4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90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308" autoAdjust="0"/>
    <p:restoredTop sz="94660"/>
  </p:normalViewPr>
  <p:slideViewPr>
    <p:cSldViewPr snapToGrid="0">
      <p:cViewPr varScale="1">
        <p:scale>
          <a:sx n="100" d="100"/>
          <a:sy n="100" d="100"/>
        </p:scale>
        <p:origin x="78" y="6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0mb1\OneDrive\Documents\&#23398;&#20250;&#12539;&#35542;&#25991;&#12539;&#30330;&#34920;\'23%20&#36229;&#38899;&#27874;&#22320;&#26041;&#20250;%20morioka\RFCA%20&#12487;&#12540;&#12479;&#12505;&#12540;&#12473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スライド用!$C$10:$D$10</c:f>
                <c:numCache>
                  <c:formatCode>General</c:formatCode>
                  <c:ptCount val="2"/>
                  <c:pt idx="0">
                    <c:v>8.5667701132346466E-2</c:v>
                  </c:pt>
                  <c:pt idx="1">
                    <c:v>5.7804400917508852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スライド用!$C$2:$D$2</c:f>
              <c:numCache>
                <c:formatCode>General</c:formatCode>
                <c:ptCount val="2"/>
              </c:numCache>
            </c:numRef>
          </c:cat>
          <c:val>
            <c:numRef>
              <c:f>スライド用!$C$3:$D$3</c:f>
              <c:numCache>
                <c:formatCode>General</c:formatCode>
                <c:ptCount val="2"/>
                <c:pt idx="0">
                  <c:v>0.16138888888888889</c:v>
                </c:pt>
                <c:pt idx="1">
                  <c:v>0.181388888888888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53D-4154-AF8B-D8CD92AABA30}"/>
            </c:ext>
          </c:extLst>
        </c:ser>
        <c:ser>
          <c:idx val="1"/>
          <c:order val="1"/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スライド用!$C$11:$D$11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6.6575812747387567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スライド用!$C$2:$D$2</c:f>
              <c:numCache>
                <c:formatCode>General</c:formatCode>
                <c:ptCount val="2"/>
              </c:numCache>
            </c:numRef>
          </c:cat>
          <c:val>
            <c:numRef>
              <c:f>スライド用!$C$4:$D$4</c:f>
              <c:numCache>
                <c:formatCode>General</c:formatCode>
                <c:ptCount val="2"/>
                <c:pt idx="0">
                  <c:v>0</c:v>
                </c:pt>
                <c:pt idx="1">
                  <c:v>0.176363636363636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53D-4154-AF8B-D8CD92AABA3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66022367"/>
        <c:axId val="970630207"/>
      </c:barChart>
      <c:catAx>
        <c:axId val="96602236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70630207"/>
        <c:crosses val="autoZero"/>
        <c:auto val="1"/>
        <c:lblAlgn val="ctr"/>
        <c:lblOffset val="100"/>
        <c:noMultiLvlLbl val="0"/>
      </c:catAx>
      <c:valAx>
        <c:axId val="970630207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96602236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EE048C9-ECCB-4A17-8CCE-DE3D21083F80}" type="datetimeFigureOut">
              <a:rPr kumimoji="1" lang="ja-JP" altLang="en-US" smtClean="0"/>
              <a:t>2025/8/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0120B1D-1543-4E8F-BF14-F09D602095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78949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80F83ED-3014-E7B3-1DF2-F10E60AB390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F44F683F-C07A-DC89-4985-DEB2EB60794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1B4D0B9-8807-17BF-ED2B-9FF71BC578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3501D-7D85-4E21-B655-6D88FA66F85B}" type="datetimeFigureOut">
              <a:rPr kumimoji="1" lang="ja-JP" altLang="en-US" smtClean="0"/>
              <a:t>2025/8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D91FC72-1DEF-33C0-7368-7033F63533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C974D39-7897-57DA-8FD5-6EFF012FFF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6A594-F70A-4E24-81CC-D39DC40FAF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32568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230A0D0-0659-F011-C4F2-20C8A9245A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AA5D75C-74BE-1746-C9B7-C18741EF0E4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4536F9E-62DB-36ED-30DB-48E39A7F25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3501D-7D85-4E21-B655-6D88FA66F85B}" type="datetimeFigureOut">
              <a:rPr kumimoji="1" lang="ja-JP" altLang="en-US" smtClean="0"/>
              <a:t>2025/8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51A376E-7FA7-BF63-C68B-AE295F0969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D00B413-9A8C-DCC5-CEC0-36B4D110AF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6A594-F70A-4E24-81CC-D39DC40FAF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25876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C70D2F11-48DA-95C2-6834-29131175C9E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8E3FCDA-DFA9-DC39-0446-C4983615E3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1975A5E-4B28-49F9-F541-2D1524F7AC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3501D-7D85-4E21-B655-6D88FA66F85B}" type="datetimeFigureOut">
              <a:rPr kumimoji="1" lang="ja-JP" altLang="en-US" smtClean="0"/>
              <a:t>2025/8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7B6DED5-039B-649B-5F32-DFF7F95D5A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6AB572F-029D-FF2F-57F0-A49BBA0EC0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6A594-F70A-4E24-81CC-D39DC40FAF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9038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E076FC5-6F64-8B8A-3BC3-F63C5C74C6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CA75DF2-FF29-4D0A-2BB2-A982915DEB9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392A26A-C5EC-4FB1-8020-948CEE7415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3501D-7D85-4E21-B655-6D88FA66F85B}" type="datetimeFigureOut">
              <a:rPr kumimoji="1" lang="ja-JP" altLang="en-US" smtClean="0"/>
              <a:t>2025/8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C0EC053-90CE-3569-BCEF-6277CAA104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0BBD742-AF0F-DAF1-4516-311BB02890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6A594-F70A-4E24-81CC-D39DC40FAF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18026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18E514D-BFE0-25EC-3FE5-D687A37313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45109AA-5B99-47B1-A810-B2E8C2548C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23ADC29-1A90-D383-7655-62AB511DF3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3501D-7D85-4E21-B655-6D88FA66F85B}" type="datetimeFigureOut">
              <a:rPr kumimoji="1" lang="ja-JP" altLang="en-US" smtClean="0"/>
              <a:t>2025/8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816683D-F2F2-22E4-BA75-7F81D642C7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57973DA-DFED-49D9-873E-ECF2991F81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6A594-F70A-4E24-81CC-D39DC40FAF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77228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E84BF36-AA92-D3F5-C575-ED0A7D9F16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C7BD42E-09F4-769A-3C05-0996C413E87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58F90C9-DEFF-47F8-C103-DDF1A4FBDBA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D0F5A73-318D-30EE-832A-1B4F7C5521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3501D-7D85-4E21-B655-6D88FA66F85B}" type="datetimeFigureOut">
              <a:rPr kumimoji="1" lang="ja-JP" altLang="en-US" smtClean="0"/>
              <a:t>2025/8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45C8D84-3AD3-42AC-B516-A2DA7462C7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53592F4-8FC7-9979-DC78-9995531EE1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6A594-F70A-4E24-81CC-D39DC40FAF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75177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E2037B7-0AF1-069F-F81E-86ADFD6422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4BF33E2-E4AF-6940-B960-4FD61EAB01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6CEAEE8-CAA0-A530-3C57-A2B56F654CC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889AA45D-8FE1-C6B9-FCE7-B475CFFFDF3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80727C9F-28CA-8890-9A49-EA3AF68DE1A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BF1D6B62-4BA3-D9AB-FA74-32360F8CC1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3501D-7D85-4E21-B655-6D88FA66F85B}" type="datetimeFigureOut">
              <a:rPr kumimoji="1" lang="ja-JP" altLang="en-US" smtClean="0"/>
              <a:t>2025/8/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038C7BC4-B787-5012-C9DE-BFB9D05EDF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679FD61E-E935-763B-BA36-79D59D2211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6A594-F70A-4E24-81CC-D39DC40FAF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50480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B50C970-B3E6-B6DD-28C1-0B33B4134B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7D0D24DB-480D-BB6A-9155-E5730E94E5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3501D-7D85-4E21-B655-6D88FA66F85B}" type="datetimeFigureOut">
              <a:rPr kumimoji="1" lang="ja-JP" altLang="en-US" smtClean="0"/>
              <a:t>2025/8/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F3200D38-3864-107D-9BFD-77ADB859F4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23C1839B-1052-F4FA-CE6F-CBCDE0E31C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6A594-F70A-4E24-81CC-D39DC40FAF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49523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92A053B8-B0E7-A636-B107-A0B7CE864E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3501D-7D85-4E21-B655-6D88FA66F85B}" type="datetimeFigureOut">
              <a:rPr kumimoji="1" lang="ja-JP" altLang="en-US" smtClean="0"/>
              <a:t>2025/8/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7EE15BCE-8785-5DD7-1FE3-6894E85949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8EA269A1-4330-7D63-123D-8FB4F329D2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6A594-F70A-4E24-81CC-D39DC40FAF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40530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03B118E-AD72-C8D4-91F2-90EF4A267A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3C24F3E-AEDB-E9F1-510A-49E8DE237CF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A48FB2F6-F2AF-B479-E643-D24DAC4EA6B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47C4B4C-25AA-66F6-A2AA-E7A5EB99B2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3501D-7D85-4E21-B655-6D88FA66F85B}" type="datetimeFigureOut">
              <a:rPr kumimoji="1" lang="ja-JP" altLang="en-US" smtClean="0"/>
              <a:t>2025/8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478484E-BEAD-1A87-C243-8F34ACCC57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F1B0293-B15F-20C1-E8B4-AC7A3B1F80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6A594-F70A-4E24-81CC-D39DC40FAF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536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1729A02-537B-BB19-760A-9573650285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EF019A42-8501-0505-BCA6-7FB07088F68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8D89E2AD-A3E6-7C44-DE08-E7693127C49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1044AE8-F2DE-DB5A-0982-ACD3A3B51E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3501D-7D85-4E21-B655-6D88FA66F85B}" type="datetimeFigureOut">
              <a:rPr kumimoji="1" lang="ja-JP" altLang="en-US" smtClean="0"/>
              <a:t>2025/8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8586D3F-F961-69FE-4B50-B03FA4C6C8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48407CB-DF30-A765-6192-3C56417332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6A594-F70A-4E24-81CC-D39DC40FAF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13481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FBD2EA8A-86DA-4571-320D-251B28B798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0142C7E-06F5-9558-8AB2-7C651484286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3C4A95B-B338-DF66-65FA-9BD4B55002B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C3501D-7D85-4E21-B655-6D88FA66F85B}" type="datetimeFigureOut">
              <a:rPr kumimoji="1" lang="ja-JP" altLang="en-US" smtClean="0"/>
              <a:t>2025/8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34D61AC-7675-9CE1-FC8A-36B775A09B5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91AA20C-078A-155A-4464-ABEE8E8CD9A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B6A594-F70A-4E24-81CC-D39DC40FAF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79528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38529149-65EB-2A35-F8F5-34077434943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21502197"/>
              </p:ext>
            </p:extLst>
          </p:nvPr>
        </p:nvGraphicFramePr>
        <p:xfrm>
          <a:off x="585749" y="1894165"/>
          <a:ext cx="457581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94C4759-A1BA-062D-C560-94D24B053D76}"/>
              </a:ext>
            </a:extLst>
          </p:cNvPr>
          <p:cNvSpPr txBox="1"/>
          <p:nvPr/>
        </p:nvSpPr>
        <p:spPr>
          <a:xfrm>
            <a:off x="1977820" y="4133236"/>
            <a:ext cx="3818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NA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62933C3-CC91-7F9F-502F-0C3D3710C7D6}"/>
              </a:ext>
            </a:extLst>
          </p:cNvPr>
          <p:cNvSpPr txBox="1"/>
          <p:nvPr/>
        </p:nvSpPr>
        <p:spPr>
          <a:xfrm>
            <a:off x="1122708" y="4493938"/>
            <a:ext cx="1582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re treatment</a:t>
            </a:r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1E154ADE-4B4C-7770-EE6F-8E19D07CA1F9}"/>
              </a:ext>
            </a:extLst>
          </p:cNvPr>
          <p:cNvSpPr txBox="1"/>
          <p:nvPr/>
        </p:nvSpPr>
        <p:spPr>
          <a:xfrm>
            <a:off x="3188576" y="4493938"/>
            <a:ext cx="17107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fter treatment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E908EFED-D4C7-4E3C-AFF6-019BC8458185}"/>
              </a:ext>
            </a:extLst>
          </p:cNvPr>
          <p:cNvSpPr/>
          <p:nvPr/>
        </p:nvSpPr>
        <p:spPr>
          <a:xfrm>
            <a:off x="2050752" y="4891240"/>
            <a:ext cx="345233" cy="158620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6E27DE1D-ADA5-CD6F-79E6-3CFD083FC169}"/>
              </a:ext>
            </a:extLst>
          </p:cNvPr>
          <p:cNvSpPr/>
          <p:nvPr/>
        </p:nvSpPr>
        <p:spPr>
          <a:xfrm>
            <a:off x="2050752" y="5150359"/>
            <a:ext cx="345233" cy="158620"/>
          </a:xfrm>
          <a:prstGeom prst="rect">
            <a:avLst/>
          </a:prstGeom>
          <a:solidFill>
            <a:schemeClr val="accent2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77B95ECC-3B64-71FE-FACB-3C5895D18246}"/>
              </a:ext>
            </a:extLst>
          </p:cNvPr>
          <p:cNvSpPr txBox="1"/>
          <p:nvPr/>
        </p:nvSpPr>
        <p:spPr>
          <a:xfrm>
            <a:off x="2395985" y="4800471"/>
            <a:ext cx="13898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aroxysmal AF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61ECE6AC-C7CF-79E0-6C18-E215D5E495CF}"/>
              </a:ext>
            </a:extLst>
          </p:cNvPr>
          <p:cNvSpPr txBox="1"/>
          <p:nvPr/>
        </p:nvSpPr>
        <p:spPr>
          <a:xfrm>
            <a:off x="2395984" y="5087241"/>
            <a:ext cx="12504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ersistent AF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オブジェクト 1">
            <a:extLst>
              <a:ext uri="{FF2B5EF4-FFF2-40B4-BE49-F238E27FC236}">
                <a16:creationId xmlns:a16="http://schemas.microsoft.com/office/drawing/2014/main" id="{18AEBBF5-3553-9E98-0A4B-84E387D7DD6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45277376"/>
              </p:ext>
            </p:extLst>
          </p:nvPr>
        </p:nvGraphicFramePr>
        <p:xfrm>
          <a:off x="6641972" y="1731059"/>
          <a:ext cx="4429613" cy="36447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3" imgW="10789920" imgH="8876514" progId="">
                  <p:embed/>
                </p:oleObj>
              </mc:Choice>
              <mc:Fallback>
                <p:oleObj r:id="rId3" imgW="10789920" imgH="8876514" progId="">
                  <p:embed/>
                  <p:pic>
                    <p:nvPicPr>
                      <p:cNvPr id="4" name="オブジェクト 3">
                        <a:extLst>
                          <a:ext uri="{FF2B5EF4-FFF2-40B4-BE49-F238E27FC236}">
                            <a16:creationId xmlns:a16="http://schemas.microsoft.com/office/drawing/2014/main" id="{D92784DC-CE8A-ED41-F626-56A9865C759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641972" y="1731059"/>
                        <a:ext cx="4429613" cy="36447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フリーフォーム: 図形 4">
            <a:extLst>
              <a:ext uri="{FF2B5EF4-FFF2-40B4-BE49-F238E27FC236}">
                <a16:creationId xmlns:a16="http://schemas.microsoft.com/office/drawing/2014/main" id="{6D799886-9917-3691-A8A1-BFE8B3AB3CDD}"/>
              </a:ext>
            </a:extLst>
          </p:cNvPr>
          <p:cNvSpPr/>
          <p:nvPr/>
        </p:nvSpPr>
        <p:spPr>
          <a:xfrm>
            <a:off x="7836311" y="2591402"/>
            <a:ext cx="467848" cy="761398"/>
          </a:xfrm>
          <a:custGeom>
            <a:avLst/>
            <a:gdLst>
              <a:gd name="connsiteX0" fmla="*/ 387539 w 1012690"/>
              <a:gd name="connsiteY0" fmla="*/ 9331 h 1268964"/>
              <a:gd name="connsiteX1" fmla="*/ 294233 w 1012690"/>
              <a:gd name="connsiteY1" fmla="*/ 27992 h 1268964"/>
              <a:gd name="connsiteX2" fmla="*/ 238249 w 1012690"/>
              <a:gd name="connsiteY2" fmla="*/ 65315 h 1268964"/>
              <a:gd name="connsiteX3" fmla="*/ 182265 w 1012690"/>
              <a:gd name="connsiteY3" fmla="*/ 121298 h 1268964"/>
              <a:gd name="connsiteX4" fmla="*/ 135612 w 1012690"/>
              <a:gd name="connsiteY4" fmla="*/ 195943 h 1268964"/>
              <a:gd name="connsiteX5" fmla="*/ 126282 w 1012690"/>
              <a:gd name="connsiteY5" fmla="*/ 223935 h 1268964"/>
              <a:gd name="connsiteX6" fmla="*/ 51637 w 1012690"/>
              <a:gd name="connsiteY6" fmla="*/ 335902 h 1268964"/>
              <a:gd name="connsiteX7" fmla="*/ 14314 w 1012690"/>
              <a:gd name="connsiteY7" fmla="*/ 447870 h 1268964"/>
              <a:gd name="connsiteX8" fmla="*/ 14314 w 1012690"/>
              <a:gd name="connsiteY8" fmla="*/ 1110343 h 1268964"/>
              <a:gd name="connsiteX9" fmla="*/ 42306 w 1012690"/>
              <a:gd name="connsiteY9" fmla="*/ 1175657 h 1268964"/>
              <a:gd name="connsiteX10" fmla="*/ 70298 w 1012690"/>
              <a:gd name="connsiteY10" fmla="*/ 1184988 h 1268964"/>
              <a:gd name="connsiteX11" fmla="*/ 107620 w 1012690"/>
              <a:gd name="connsiteY11" fmla="*/ 1231641 h 1268964"/>
              <a:gd name="connsiteX12" fmla="*/ 126282 w 1012690"/>
              <a:gd name="connsiteY12" fmla="*/ 1250302 h 1268964"/>
              <a:gd name="connsiteX13" fmla="*/ 200926 w 1012690"/>
              <a:gd name="connsiteY13" fmla="*/ 1268964 h 1268964"/>
              <a:gd name="connsiteX14" fmla="*/ 294233 w 1012690"/>
              <a:gd name="connsiteY14" fmla="*/ 1259633 h 1268964"/>
              <a:gd name="connsiteX15" fmla="*/ 368877 w 1012690"/>
              <a:gd name="connsiteY15" fmla="*/ 1240972 h 1268964"/>
              <a:gd name="connsiteX16" fmla="*/ 490175 w 1012690"/>
              <a:gd name="connsiteY16" fmla="*/ 1194319 h 1268964"/>
              <a:gd name="connsiteX17" fmla="*/ 536828 w 1012690"/>
              <a:gd name="connsiteY17" fmla="*/ 1166327 h 1268964"/>
              <a:gd name="connsiteX18" fmla="*/ 583482 w 1012690"/>
              <a:gd name="connsiteY18" fmla="*/ 1119674 h 1268964"/>
              <a:gd name="connsiteX19" fmla="*/ 648796 w 1012690"/>
              <a:gd name="connsiteY19" fmla="*/ 1026368 h 1268964"/>
              <a:gd name="connsiteX20" fmla="*/ 676788 w 1012690"/>
              <a:gd name="connsiteY20" fmla="*/ 970384 h 1268964"/>
              <a:gd name="connsiteX21" fmla="*/ 686118 w 1012690"/>
              <a:gd name="connsiteY21" fmla="*/ 933061 h 1268964"/>
              <a:gd name="connsiteX22" fmla="*/ 788755 w 1012690"/>
              <a:gd name="connsiteY22" fmla="*/ 783772 h 1268964"/>
              <a:gd name="connsiteX23" fmla="*/ 910053 w 1012690"/>
              <a:gd name="connsiteY23" fmla="*/ 597159 h 1268964"/>
              <a:gd name="connsiteX24" fmla="*/ 928714 w 1012690"/>
              <a:gd name="connsiteY24" fmla="*/ 541176 h 1268964"/>
              <a:gd name="connsiteX25" fmla="*/ 947375 w 1012690"/>
              <a:gd name="connsiteY25" fmla="*/ 503853 h 1268964"/>
              <a:gd name="connsiteX26" fmla="*/ 956706 w 1012690"/>
              <a:gd name="connsiteY26" fmla="*/ 457200 h 1268964"/>
              <a:gd name="connsiteX27" fmla="*/ 966037 w 1012690"/>
              <a:gd name="connsiteY27" fmla="*/ 363894 h 1268964"/>
              <a:gd name="connsiteX28" fmla="*/ 994028 w 1012690"/>
              <a:gd name="connsiteY28" fmla="*/ 289249 h 1268964"/>
              <a:gd name="connsiteX29" fmla="*/ 1012690 w 1012690"/>
              <a:gd name="connsiteY29" fmla="*/ 186613 h 1268964"/>
              <a:gd name="connsiteX30" fmla="*/ 984698 w 1012690"/>
              <a:gd name="connsiteY30" fmla="*/ 83976 h 1268964"/>
              <a:gd name="connsiteX31" fmla="*/ 900722 w 1012690"/>
              <a:gd name="connsiteY31" fmla="*/ 27992 h 1268964"/>
              <a:gd name="connsiteX32" fmla="*/ 844739 w 1012690"/>
              <a:gd name="connsiteY32" fmla="*/ 0 h 1268964"/>
              <a:gd name="connsiteX33" fmla="*/ 592812 w 1012690"/>
              <a:gd name="connsiteY33" fmla="*/ 9331 h 1268964"/>
              <a:gd name="connsiteX34" fmla="*/ 527498 w 1012690"/>
              <a:gd name="connsiteY34" fmla="*/ 18661 h 1268964"/>
              <a:gd name="connsiteX35" fmla="*/ 387539 w 1012690"/>
              <a:gd name="connsiteY35" fmla="*/ 9331 h 126896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</a:cxnLst>
            <a:rect l="l" t="t" r="r" b="b"/>
            <a:pathLst>
              <a:path w="1012690" h="1268964">
                <a:moveTo>
                  <a:pt x="387539" y="9331"/>
                </a:moveTo>
                <a:cubicBezTo>
                  <a:pt x="348662" y="10886"/>
                  <a:pt x="312001" y="16147"/>
                  <a:pt x="294233" y="27992"/>
                </a:cubicBezTo>
                <a:cubicBezTo>
                  <a:pt x="224342" y="74587"/>
                  <a:pt x="304805" y="43129"/>
                  <a:pt x="238249" y="65315"/>
                </a:cubicBezTo>
                <a:cubicBezTo>
                  <a:pt x="219588" y="83976"/>
                  <a:pt x="198570" y="100546"/>
                  <a:pt x="182265" y="121298"/>
                </a:cubicBezTo>
                <a:cubicBezTo>
                  <a:pt x="164137" y="144370"/>
                  <a:pt x="149662" y="170184"/>
                  <a:pt x="135612" y="195943"/>
                </a:cubicBezTo>
                <a:cubicBezTo>
                  <a:pt x="130902" y="204577"/>
                  <a:pt x="131495" y="215595"/>
                  <a:pt x="126282" y="223935"/>
                </a:cubicBezTo>
                <a:cubicBezTo>
                  <a:pt x="79596" y="298633"/>
                  <a:pt x="90906" y="242639"/>
                  <a:pt x="51637" y="335902"/>
                </a:cubicBezTo>
                <a:cubicBezTo>
                  <a:pt x="36370" y="372161"/>
                  <a:pt x="14314" y="447870"/>
                  <a:pt x="14314" y="447870"/>
                </a:cubicBezTo>
                <a:cubicBezTo>
                  <a:pt x="-7469" y="731070"/>
                  <a:pt x="-1870" y="608639"/>
                  <a:pt x="14314" y="1110343"/>
                </a:cubicBezTo>
                <a:cubicBezTo>
                  <a:pt x="14908" y="1128747"/>
                  <a:pt x="26550" y="1163052"/>
                  <a:pt x="42306" y="1175657"/>
                </a:cubicBezTo>
                <a:cubicBezTo>
                  <a:pt x="49986" y="1181801"/>
                  <a:pt x="60967" y="1181878"/>
                  <a:pt x="70298" y="1184988"/>
                </a:cubicBezTo>
                <a:cubicBezTo>
                  <a:pt x="82739" y="1200539"/>
                  <a:pt x="94659" y="1216521"/>
                  <a:pt x="107620" y="1231641"/>
                </a:cubicBezTo>
                <a:cubicBezTo>
                  <a:pt x="113345" y="1238320"/>
                  <a:pt x="118114" y="1247035"/>
                  <a:pt x="126282" y="1250302"/>
                </a:cubicBezTo>
                <a:cubicBezTo>
                  <a:pt x="150095" y="1259827"/>
                  <a:pt x="176045" y="1262743"/>
                  <a:pt x="200926" y="1268964"/>
                </a:cubicBezTo>
                <a:cubicBezTo>
                  <a:pt x="232028" y="1265854"/>
                  <a:pt x="263401" y="1264772"/>
                  <a:pt x="294233" y="1259633"/>
                </a:cubicBezTo>
                <a:cubicBezTo>
                  <a:pt x="319531" y="1255417"/>
                  <a:pt x="344096" y="1247580"/>
                  <a:pt x="368877" y="1240972"/>
                </a:cubicBezTo>
                <a:cubicBezTo>
                  <a:pt x="434926" y="1223359"/>
                  <a:pt x="431747" y="1226188"/>
                  <a:pt x="490175" y="1194319"/>
                </a:cubicBezTo>
                <a:cubicBezTo>
                  <a:pt x="506096" y="1185635"/>
                  <a:pt x="522667" y="1177656"/>
                  <a:pt x="536828" y="1166327"/>
                </a:cubicBezTo>
                <a:cubicBezTo>
                  <a:pt x="554001" y="1152588"/>
                  <a:pt x="568770" y="1136021"/>
                  <a:pt x="583482" y="1119674"/>
                </a:cubicBezTo>
                <a:cubicBezTo>
                  <a:pt x="613085" y="1086782"/>
                  <a:pt x="627904" y="1064671"/>
                  <a:pt x="648796" y="1026368"/>
                </a:cubicBezTo>
                <a:cubicBezTo>
                  <a:pt x="658787" y="1008052"/>
                  <a:pt x="667457" y="989045"/>
                  <a:pt x="676788" y="970384"/>
                </a:cubicBezTo>
                <a:cubicBezTo>
                  <a:pt x="679898" y="957943"/>
                  <a:pt x="680383" y="944531"/>
                  <a:pt x="686118" y="933061"/>
                </a:cubicBezTo>
                <a:cubicBezTo>
                  <a:pt x="744592" y="816112"/>
                  <a:pt x="725584" y="869503"/>
                  <a:pt x="788755" y="783772"/>
                </a:cubicBezTo>
                <a:cubicBezTo>
                  <a:pt x="814112" y="749359"/>
                  <a:pt x="885501" y="650356"/>
                  <a:pt x="910053" y="597159"/>
                </a:cubicBezTo>
                <a:cubicBezTo>
                  <a:pt x="918296" y="579299"/>
                  <a:pt x="921409" y="559440"/>
                  <a:pt x="928714" y="541176"/>
                </a:cubicBezTo>
                <a:cubicBezTo>
                  <a:pt x="933880" y="528261"/>
                  <a:pt x="941155" y="516294"/>
                  <a:pt x="947375" y="503853"/>
                </a:cubicBezTo>
                <a:cubicBezTo>
                  <a:pt x="950485" y="488302"/>
                  <a:pt x="954610" y="472920"/>
                  <a:pt x="956706" y="457200"/>
                </a:cubicBezTo>
                <a:cubicBezTo>
                  <a:pt x="960837" y="426217"/>
                  <a:pt x="959256" y="394407"/>
                  <a:pt x="966037" y="363894"/>
                </a:cubicBezTo>
                <a:cubicBezTo>
                  <a:pt x="971802" y="337953"/>
                  <a:pt x="986213" y="314647"/>
                  <a:pt x="994028" y="289249"/>
                </a:cubicBezTo>
                <a:cubicBezTo>
                  <a:pt x="998770" y="273836"/>
                  <a:pt x="1010652" y="198843"/>
                  <a:pt x="1012690" y="186613"/>
                </a:cubicBezTo>
                <a:cubicBezTo>
                  <a:pt x="1003359" y="152401"/>
                  <a:pt x="1000557" y="115694"/>
                  <a:pt x="984698" y="83976"/>
                </a:cubicBezTo>
                <a:cubicBezTo>
                  <a:pt x="954372" y="23324"/>
                  <a:pt x="944573" y="45533"/>
                  <a:pt x="900722" y="27992"/>
                </a:cubicBezTo>
                <a:cubicBezTo>
                  <a:pt x="881351" y="20243"/>
                  <a:pt x="863400" y="9331"/>
                  <a:pt x="844739" y="0"/>
                </a:cubicBezTo>
                <a:cubicBezTo>
                  <a:pt x="760763" y="3110"/>
                  <a:pt x="676700" y="4396"/>
                  <a:pt x="592812" y="9331"/>
                </a:cubicBezTo>
                <a:cubicBezTo>
                  <a:pt x="570858" y="10622"/>
                  <a:pt x="549414" y="16835"/>
                  <a:pt x="527498" y="18661"/>
                </a:cubicBezTo>
                <a:cubicBezTo>
                  <a:pt x="474716" y="23059"/>
                  <a:pt x="426416" y="7776"/>
                  <a:pt x="387539" y="9331"/>
                </a:cubicBezTo>
                <a:close/>
              </a:path>
            </a:pathLst>
          </a:custGeom>
          <a:noFill/>
          <a:ln w="63500"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8" name="フリーフォーム: 図形 7">
            <a:extLst>
              <a:ext uri="{FF2B5EF4-FFF2-40B4-BE49-F238E27FC236}">
                <a16:creationId xmlns:a16="http://schemas.microsoft.com/office/drawing/2014/main" id="{0731C14F-626A-5786-0BA0-5ADCB0FCE748}"/>
              </a:ext>
            </a:extLst>
          </p:cNvPr>
          <p:cNvSpPr/>
          <p:nvPr/>
        </p:nvSpPr>
        <p:spPr>
          <a:xfrm>
            <a:off x="9514058" y="3089785"/>
            <a:ext cx="248192" cy="966585"/>
          </a:xfrm>
          <a:custGeom>
            <a:avLst/>
            <a:gdLst>
              <a:gd name="connsiteX0" fmla="*/ 78658 w 386000"/>
              <a:gd name="connsiteY0" fmla="*/ 3024 h 966585"/>
              <a:gd name="connsiteX1" fmla="*/ 176980 w 386000"/>
              <a:gd name="connsiteY1" fmla="*/ 32521 h 966585"/>
              <a:gd name="connsiteX2" fmla="*/ 265471 w 386000"/>
              <a:gd name="connsiteY2" fmla="*/ 62018 h 966585"/>
              <a:gd name="connsiteX3" fmla="*/ 304800 w 386000"/>
              <a:gd name="connsiteY3" fmla="*/ 101347 h 966585"/>
              <a:gd name="connsiteX4" fmla="*/ 334296 w 386000"/>
              <a:gd name="connsiteY4" fmla="*/ 111179 h 966585"/>
              <a:gd name="connsiteX5" fmla="*/ 363793 w 386000"/>
              <a:gd name="connsiteY5" fmla="*/ 160340 h 966585"/>
              <a:gd name="connsiteX6" fmla="*/ 373625 w 386000"/>
              <a:gd name="connsiteY6" fmla="*/ 406147 h 966585"/>
              <a:gd name="connsiteX7" fmla="*/ 353961 w 386000"/>
              <a:gd name="connsiteY7" fmla="*/ 445476 h 966585"/>
              <a:gd name="connsiteX8" fmla="*/ 334296 w 386000"/>
              <a:gd name="connsiteY8" fmla="*/ 553631 h 966585"/>
              <a:gd name="connsiteX9" fmla="*/ 324464 w 386000"/>
              <a:gd name="connsiteY9" fmla="*/ 642121 h 966585"/>
              <a:gd name="connsiteX10" fmla="*/ 304800 w 386000"/>
              <a:gd name="connsiteY10" fmla="*/ 691282 h 966585"/>
              <a:gd name="connsiteX11" fmla="*/ 294967 w 386000"/>
              <a:gd name="connsiteY11" fmla="*/ 789605 h 966585"/>
              <a:gd name="connsiteX12" fmla="*/ 285135 w 386000"/>
              <a:gd name="connsiteY12" fmla="*/ 897760 h 966585"/>
              <a:gd name="connsiteX13" fmla="*/ 245806 w 386000"/>
              <a:gd name="connsiteY13" fmla="*/ 966585 h 966585"/>
              <a:gd name="connsiteX14" fmla="*/ 235974 w 386000"/>
              <a:gd name="connsiteY14" fmla="*/ 937089 h 966585"/>
              <a:gd name="connsiteX15" fmla="*/ 206477 w 386000"/>
              <a:gd name="connsiteY15" fmla="*/ 907592 h 966585"/>
              <a:gd name="connsiteX16" fmla="*/ 196645 w 386000"/>
              <a:gd name="connsiteY16" fmla="*/ 779772 h 966585"/>
              <a:gd name="connsiteX17" fmla="*/ 186812 w 386000"/>
              <a:gd name="connsiteY17" fmla="*/ 681450 h 966585"/>
              <a:gd name="connsiteX18" fmla="*/ 137651 w 386000"/>
              <a:gd name="connsiteY18" fmla="*/ 622456 h 966585"/>
              <a:gd name="connsiteX19" fmla="*/ 127819 w 386000"/>
              <a:gd name="connsiteY19" fmla="*/ 592960 h 966585"/>
              <a:gd name="connsiteX20" fmla="*/ 98322 w 386000"/>
              <a:gd name="connsiteY20" fmla="*/ 563463 h 966585"/>
              <a:gd name="connsiteX21" fmla="*/ 49161 w 386000"/>
              <a:gd name="connsiteY21" fmla="*/ 445476 h 966585"/>
              <a:gd name="connsiteX22" fmla="*/ 29496 w 386000"/>
              <a:gd name="connsiteY22" fmla="*/ 347153 h 966585"/>
              <a:gd name="connsiteX23" fmla="*/ 9832 w 386000"/>
              <a:gd name="connsiteY23" fmla="*/ 288160 h 966585"/>
              <a:gd name="connsiteX24" fmla="*/ 0 w 386000"/>
              <a:gd name="connsiteY24" fmla="*/ 238998 h 966585"/>
              <a:gd name="connsiteX25" fmla="*/ 9832 w 386000"/>
              <a:gd name="connsiteY25" fmla="*/ 71850 h 966585"/>
              <a:gd name="connsiteX26" fmla="*/ 39329 w 386000"/>
              <a:gd name="connsiteY26" fmla="*/ 3024 h 966585"/>
              <a:gd name="connsiteX27" fmla="*/ 78658 w 386000"/>
              <a:gd name="connsiteY27" fmla="*/ 3024 h 96658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</a:cxnLst>
            <a:rect l="l" t="t" r="r" b="b"/>
            <a:pathLst>
              <a:path w="386000" h="966585">
                <a:moveTo>
                  <a:pt x="78658" y="3024"/>
                </a:moveTo>
                <a:cubicBezTo>
                  <a:pt x="101600" y="7940"/>
                  <a:pt x="60666" y="-712"/>
                  <a:pt x="176980" y="32521"/>
                </a:cubicBezTo>
                <a:cubicBezTo>
                  <a:pt x="206876" y="41063"/>
                  <a:pt x="265471" y="62018"/>
                  <a:pt x="265471" y="62018"/>
                </a:cubicBezTo>
                <a:cubicBezTo>
                  <a:pt x="278581" y="75128"/>
                  <a:pt x="289714" y="90571"/>
                  <a:pt x="304800" y="101347"/>
                </a:cubicBezTo>
                <a:cubicBezTo>
                  <a:pt x="313233" y="107371"/>
                  <a:pt x="326968" y="103851"/>
                  <a:pt x="334296" y="111179"/>
                </a:cubicBezTo>
                <a:cubicBezTo>
                  <a:pt x="347809" y="124692"/>
                  <a:pt x="353961" y="143953"/>
                  <a:pt x="363793" y="160340"/>
                </a:cubicBezTo>
                <a:cubicBezTo>
                  <a:pt x="386867" y="275709"/>
                  <a:pt x="394900" y="271406"/>
                  <a:pt x="373625" y="406147"/>
                </a:cubicBezTo>
                <a:cubicBezTo>
                  <a:pt x="371339" y="420625"/>
                  <a:pt x="360516" y="432366"/>
                  <a:pt x="353961" y="445476"/>
                </a:cubicBezTo>
                <a:cubicBezTo>
                  <a:pt x="346548" y="482540"/>
                  <a:pt x="339326" y="515905"/>
                  <a:pt x="334296" y="553631"/>
                </a:cubicBezTo>
                <a:cubicBezTo>
                  <a:pt x="330374" y="583049"/>
                  <a:pt x="330682" y="613102"/>
                  <a:pt x="324464" y="642121"/>
                </a:cubicBezTo>
                <a:cubicBezTo>
                  <a:pt x="320766" y="659379"/>
                  <a:pt x="311355" y="674895"/>
                  <a:pt x="304800" y="691282"/>
                </a:cubicBezTo>
                <a:cubicBezTo>
                  <a:pt x="301522" y="724056"/>
                  <a:pt x="298090" y="756816"/>
                  <a:pt x="294967" y="789605"/>
                </a:cubicBezTo>
                <a:cubicBezTo>
                  <a:pt x="291535" y="825642"/>
                  <a:pt x="289365" y="861808"/>
                  <a:pt x="285135" y="897760"/>
                </a:cubicBezTo>
                <a:cubicBezTo>
                  <a:pt x="277131" y="965799"/>
                  <a:pt x="292380" y="951061"/>
                  <a:pt x="245806" y="966585"/>
                </a:cubicBezTo>
                <a:cubicBezTo>
                  <a:pt x="242529" y="956753"/>
                  <a:pt x="241723" y="945712"/>
                  <a:pt x="235974" y="937089"/>
                </a:cubicBezTo>
                <a:cubicBezTo>
                  <a:pt x="228261" y="925519"/>
                  <a:pt x="209849" y="921082"/>
                  <a:pt x="206477" y="907592"/>
                </a:cubicBezTo>
                <a:cubicBezTo>
                  <a:pt x="196113" y="866135"/>
                  <a:pt x="200347" y="822344"/>
                  <a:pt x="196645" y="779772"/>
                </a:cubicBezTo>
                <a:cubicBezTo>
                  <a:pt x="193792" y="746958"/>
                  <a:pt x="198377" y="712290"/>
                  <a:pt x="186812" y="681450"/>
                </a:cubicBezTo>
                <a:cubicBezTo>
                  <a:pt x="177824" y="657482"/>
                  <a:pt x="154038" y="642121"/>
                  <a:pt x="137651" y="622456"/>
                </a:cubicBezTo>
                <a:cubicBezTo>
                  <a:pt x="134374" y="612624"/>
                  <a:pt x="133568" y="601583"/>
                  <a:pt x="127819" y="592960"/>
                </a:cubicBezTo>
                <a:cubicBezTo>
                  <a:pt x="120106" y="581390"/>
                  <a:pt x="104076" y="576122"/>
                  <a:pt x="98322" y="563463"/>
                </a:cubicBezTo>
                <a:cubicBezTo>
                  <a:pt x="25588" y="403447"/>
                  <a:pt x="124643" y="546117"/>
                  <a:pt x="49161" y="445476"/>
                </a:cubicBezTo>
                <a:cubicBezTo>
                  <a:pt x="21895" y="363676"/>
                  <a:pt x="63391" y="494030"/>
                  <a:pt x="29496" y="347153"/>
                </a:cubicBezTo>
                <a:cubicBezTo>
                  <a:pt x="24835" y="326956"/>
                  <a:pt x="15286" y="308158"/>
                  <a:pt x="9832" y="288160"/>
                </a:cubicBezTo>
                <a:cubicBezTo>
                  <a:pt x="5435" y="272037"/>
                  <a:pt x="3277" y="255385"/>
                  <a:pt x="0" y="238998"/>
                </a:cubicBezTo>
                <a:cubicBezTo>
                  <a:pt x="3277" y="183282"/>
                  <a:pt x="4279" y="127385"/>
                  <a:pt x="9832" y="71850"/>
                </a:cubicBezTo>
                <a:cubicBezTo>
                  <a:pt x="11942" y="50748"/>
                  <a:pt x="32504" y="20086"/>
                  <a:pt x="39329" y="3024"/>
                </a:cubicBezTo>
                <a:cubicBezTo>
                  <a:pt x="40546" y="-19"/>
                  <a:pt x="55716" y="-1892"/>
                  <a:pt x="78658" y="3024"/>
                </a:cubicBezTo>
                <a:close/>
              </a:path>
            </a:pathLst>
          </a:custGeom>
          <a:noFill/>
          <a:ln w="63500"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740B3329-A5D3-DDB8-7CAC-3A2CBA1C6BD0}"/>
              </a:ext>
            </a:extLst>
          </p:cNvPr>
          <p:cNvSpPr txBox="1"/>
          <p:nvPr/>
        </p:nvSpPr>
        <p:spPr>
          <a:xfrm>
            <a:off x="495105" y="1361727"/>
            <a:ext cx="3513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A365F29A-657E-AB00-197B-15237A760B17}"/>
              </a:ext>
            </a:extLst>
          </p:cNvPr>
          <p:cNvSpPr txBox="1"/>
          <p:nvPr/>
        </p:nvSpPr>
        <p:spPr>
          <a:xfrm>
            <a:off x="6641972" y="1361727"/>
            <a:ext cx="3513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F164E7FC-E157-F09D-8F4E-4679687258DB}"/>
              </a:ext>
            </a:extLst>
          </p:cNvPr>
          <p:cNvSpPr txBox="1"/>
          <p:nvPr/>
        </p:nvSpPr>
        <p:spPr>
          <a:xfrm>
            <a:off x="580150" y="1703880"/>
            <a:ext cx="4331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/s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6D2DBB3B-41DE-9D1C-CF05-E645B7C6B7CE}"/>
              </a:ext>
            </a:extLst>
          </p:cNvPr>
          <p:cNvSpPr txBox="1"/>
          <p:nvPr/>
        </p:nvSpPr>
        <p:spPr>
          <a:xfrm rot="16200000">
            <a:off x="-296523" y="2888786"/>
            <a:ext cx="16268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PVa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wave velocity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A7CC5DC8-DF1A-7023-0AD5-78D0B1AEFC61}"/>
              </a:ext>
            </a:extLst>
          </p:cNvPr>
          <p:cNvSpPr txBox="1"/>
          <p:nvPr/>
        </p:nvSpPr>
        <p:spPr>
          <a:xfrm>
            <a:off x="7030478" y="2152700"/>
            <a:ext cx="6447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LSPV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F30FECAB-CD83-D343-6CC0-3A97C9DD1906}"/>
              </a:ext>
            </a:extLst>
          </p:cNvPr>
          <p:cNvSpPr txBox="1"/>
          <p:nvPr/>
        </p:nvSpPr>
        <p:spPr>
          <a:xfrm>
            <a:off x="7120972" y="2888785"/>
            <a:ext cx="5741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LIPV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B7C50B01-0F1A-3D53-CDDC-D187BC35BB64}"/>
              </a:ext>
            </a:extLst>
          </p:cNvPr>
          <p:cNvSpPr txBox="1"/>
          <p:nvPr/>
        </p:nvSpPr>
        <p:spPr>
          <a:xfrm>
            <a:off x="9762250" y="3626715"/>
            <a:ext cx="6046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RIPV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D91F8C45-691E-A17C-A022-94C5F8236879}"/>
              </a:ext>
            </a:extLst>
          </p:cNvPr>
          <p:cNvSpPr txBox="1"/>
          <p:nvPr/>
        </p:nvSpPr>
        <p:spPr>
          <a:xfrm>
            <a:off x="10104875" y="2917190"/>
            <a:ext cx="6751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RSPV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フリーフォーム: 図形 22">
            <a:extLst>
              <a:ext uri="{FF2B5EF4-FFF2-40B4-BE49-F238E27FC236}">
                <a16:creationId xmlns:a16="http://schemas.microsoft.com/office/drawing/2014/main" id="{75FA2F7A-43E1-4E31-5D10-1413B71B054E}"/>
              </a:ext>
            </a:extLst>
          </p:cNvPr>
          <p:cNvSpPr/>
          <p:nvPr/>
        </p:nvSpPr>
        <p:spPr>
          <a:xfrm>
            <a:off x="7124700" y="3505200"/>
            <a:ext cx="299262" cy="304939"/>
          </a:xfrm>
          <a:custGeom>
            <a:avLst/>
            <a:gdLst>
              <a:gd name="connsiteX0" fmla="*/ 180975 w 299262"/>
              <a:gd name="connsiteY0" fmla="*/ 304800 h 304939"/>
              <a:gd name="connsiteX1" fmla="*/ 66675 w 299262"/>
              <a:gd name="connsiteY1" fmla="*/ 285750 h 304939"/>
              <a:gd name="connsiteX2" fmla="*/ 9525 w 299262"/>
              <a:gd name="connsiteY2" fmla="*/ 266700 h 304939"/>
              <a:gd name="connsiteX3" fmla="*/ 0 w 299262"/>
              <a:gd name="connsiteY3" fmla="*/ 209550 h 304939"/>
              <a:gd name="connsiteX4" fmla="*/ 19050 w 299262"/>
              <a:gd name="connsiteY4" fmla="*/ 142875 h 304939"/>
              <a:gd name="connsiteX5" fmla="*/ 47625 w 299262"/>
              <a:gd name="connsiteY5" fmla="*/ 85725 h 304939"/>
              <a:gd name="connsiteX6" fmla="*/ 57150 w 299262"/>
              <a:gd name="connsiteY6" fmla="*/ 38100 h 304939"/>
              <a:gd name="connsiteX7" fmla="*/ 104775 w 299262"/>
              <a:gd name="connsiteY7" fmla="*/ 0 h 304939"/>
              <a:gd name="connsiteX8" fmla="*/ 266700 w 299262"/>
              <a:gd name="connsiteY8" fmla="*/ 9525 h 304939"/>
              <a:gd name="connsiteX9" fmla="*/ 295275 w 299262"/>
              <a:gd name="connsiteY9" fmla="*/ 47625 h 304939"/>
              <a:gd name="connsiteX10" fmla="*/ 285750 w 299262"/>
              <a:gd name="connsiteY10" fmla="*/ 228600 h 304939"/>
              <a:gd name="connsiteX11" fmla="*/ 200025 w 299262"/>
              <a:gd name="connsiteY11" fmla="*/ 276225 h 304939"/>
              <a:gd name="connsiteX12" fmla="*/ 180975 w 299262"/>
              <a:gd name="connsiteY12" fmla="*/ 304800 h 3049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</a:cxnLst>
            <a:rect l="l" t="t" r="r" b="b"/>
            <a:pathLst>
              <a:path w="299262" h="304939">
                <a:moveTo>
                  <a:pt x="180975" y="304800"/>
                </a:moveTo>
                <a:cubicBezTo>
                  <a:pt x="158750" y="306387"/>
                  <a:pt x="104381" y="294129"/>
                  <a:pt x="66675" y="285750"/>
                </a:cubicBezTo>
                <a:cubicBezTo>
                  <a:pt x="47073" y="281394"/>
                  <a:pt x="22748" y="281812"/>
                  <a:pt x="9525" y="266700"/>
                </a:cubicBezTo>
                <a:cubicBezTo>
                  <a:pt x="-3193" y="252166"/>
                  <a:pt x="3175" y="228600"/>
                  <a:pt x="0" y="209550"/>
                </a:cubicBezTo>
                <a:cubicBezTo>
                  <a:pt x="3052" y="197343"/>
                  <a:pt x="12218" y="156540"/>
                  <a:pt x="19050" y="142875"/>
                </a:cubicBezTo>
                <a:cubicBezTo>
                  <a:pt x="42330" y="96314"/>
                  <a:pt x="35654" y="133608"/>
                  <a:pt x="47625" y="85725"/>
                </a:cubicBezTo>
                <a:cubicBezTo>
                  <a:pt x="51552" y="70019"/>
                  <a:pt x="48170" y="51570"/>
                  <a:pt x="57150" y="38100"/>
                </a:cubicBezTo>
                <a:cubicBezTo>
                  <a:pt x="68427" y="21184"/>
                  <a:pt x="88900" y="12700"/>
                  <a:pt x="104775" y="0"/>
                </a:cubicBezTo>
                <a:cubicBezTo>
                  <a:pt x="158750" y="3175"/>
                  <a:pt x="214246" y="-3588"/>
                  <a:pt x="266700" y="9525"/>
                </a:cubicBezTo>
                <a:cubicBezTo>
                  <a:pt x="282101" y="13375"/>
                  <a:pt x="293900" y="31810"/>
                  <a:pt x="295275" y="47625"/>
                </a:cubicBezTo>
                <a:cubicBezTo>
                  <a:pt x="300508" y="107806"/>
                  <a:pt x="303339" y="170809"/>
                  <a:pt x="285750" y="228600"/>
                </a:cubicBezTo>
                <a:cubicBezTo>
                  <a:pt x="271153" y="276562"/>
                  <a:pt x="227996" y="257578"/>
                  <a:pt x="200025" y="276225"/>
                </a:cubicBezTo>
                <a:cubicBezTo>
                  <a:pt x="197383" y="277986"/>
                  <a:pt x="203200" y="303213"/>
                  <a:pt x="180975" y="304800"/>
                </a:cubicBezTo>
                <a:close/>
              </a:path>
            </a:pathLst>
          </a:custGeom>
          <a:noFill/>
          <a:ln w="76200"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" name="フリーフォーム: 図形 25">
            <a:extLst>
              <a:ext uri="{FF2B5EF4-FFF2-40B4-BE49-F238E27FC236}">
                <a16:creationId xmlns:a16="http://schemas.microsoft.com/office/drawing/2014/main" id="{3269B223-BFCB-7839-37BF-6F2D5325AE22}"/>
              </a:ext>
            </a:extLst>
          </p:cNvPr>
          <p:cNvSpPr/>
          <p:nvPr/>
        </p:nvSpPr>
        <p:spPr>
          <a:xfrm>
            <a:off x="8580711" y="4359724"/>
            <a:ext cx="678047" cy="400298"/>
          </a:xfrm>
          <a:custGeom>
            <a:avLst/>
            <a:gdLst>
              <a:gd name="connsiteX0" fmla="*/ 427512 w 678047"/>
              <a:gd name="connsiteY0" fmla="*/ 8412 h 400298"/>
              <a:gd name="connsiteX1" fmla="*/ 439387 w 678047"/>
              <a:gd name="connsiteY1" fmla="*/ 67789 h 400298"/>
              <a:gd name="connsiteX2" fmla="*/ 486889 w 678047"/>
              <a:gd name="connsiteY2" fmla="*/ 103415 h 400298"/>
              <a:gd name="connsiteX3" fmla="*/ 522515 w 678047"/>
              <a:gd name="connsiteY3" fmla="*/ 127165 h 400298"/>
              <a:gd name="connsiteX4" fmla="*/ 558141 w 678047"/>
              <a:gd name="connsiteY4" fmla="*/ 162791 h 400298"/>
              <a:gd name="connsiteX5" fmla="*/ 641268 w 678047"/>
              <a:gd name="connsiteY5" fmla="*/ 186542 h 400298"/>
              <a:gd name="connsiteX6" fmla="*/ 653143 w 678047"/>
              <a:gd name="connsiteY6" fmla="*/ 222168 h 400298"/>
              <a:gd name="connsiteX7" fmla="*/ 676894 w 678047"/>
              <a:gd name="connsiteY7" fmla="*/ 269669 h 400298"/>
              <a:gd name="connsiteX8" fmla="*/ 629393 w 678047"/>
              <a:gd name="connsiteY8" fmla="*/ 281545 h 400298"/>
              <a:gd name="connsiteX9" fmla="*/ 534390 w 678047"/>
              <a:gd name="connsiteY9" fmla="*/ 317171 h 400298"/>
              <a:gd name="connsiteX10" fmla="*/ 498764 w 678047"/>
              <a:gd name="connsiteY10" fmla="*/ 340921 h 400298"/>
              <a:gd name="connsiteX11" fmla="*/ 475013 w 678047"/>
              <a:gd name="connsiteY11" fmla="*/ 388423 h 400298"/>
              <a:gd name="connsiteX12" fmla="*/ 427512 w 678047"/>
              <a:gd name="connsiteY12" fmla="*/ 400298 h 400298"/>
              <a:gd name="connsiteX13" fmla="*/ 249382 w 678047"/>
              <a:gd name="connsiteY13" fmla="*/ 388423 h 400298"/>
              <a:gd name="connsiteX14" fmla="*/ 190006 w 678047"/>
              <a:gd name="connsiteY14" fmla="*/ 376547 h 400298"/>
              <a:gd name="connsiteX15" fmla="*/ 95003 w 678047"/>
              <a:gd name="connsiteY15" fmla="*/ 352797 h 400298"/>
              <a:gd name="connsiteX16" fmla="*/ 0 w 678047"/>
              <a:gd name="connsiteY16" fmla="*/ 340921 h 400298"/>
              <a:gd name="connsiteX17" fmla="*/ 106878 w 678047"/>
              <a:gd name="connsiteY17" fmla="*/ 269669 h 400298"/>
              <a:gd name="connsiteX18" fmla="*/ 154380 w 678047"/>
              <a:gd name="connsiteY18" fmla="*/ 245919 h 400298"/>
              <a:gd name="connsiteX19" fmla="*/ 201881 w 678047"/>
              <a:gd name="connsiteY19" fmla="*/ 234043 h 400298"/>
              <a:gd name="connsiteX20" fmla="*/ 249382 w 678047"/>
              <a:gd name="connsiteY20" fmla="*/ 162791 h 400298"/>
              <a:gd name="connsiteX21" fmla="*/ 285008 w 678047"/>
              <a:gd name="connsiteY21" fmla="*/ 127165 h 400298"/>
              <a:gd name="connsiteX22" fmla="*/ 344385 w 678047"/>
              <a:gd name="connsiteY22" fmla="*/ 55913 h 400298"/>
              <a:gd name="connsiteX23" fmla="*/ 356260 w 678047"/>
              <a:gd name="connsiteY23" fmla="*/ 20287 h 400298"/>
              <a:gd name="connsiteX24" fmla="*/ 427512 w 678047"/>
              <a:gd name="connsiteY24" fmla="*/ 8412 h 40029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</a:cxnLst>
            <a:rect l="l" t="t" r="r" b="b"/>
            <a:pathLst>
              <a:path w="678047" h="400298">
                <a:moveTo>
                  <a:pt x="427512" y="8412"/>
                </a:moveTo>
                <a:cubicBezTo>
                  <a:pt x="441366" y="16329"/>
                  <a:pt x="428689" y="50673"/>
                  <a:pt x="439387" y="67789"/>
                </a:cubicBezTo>
                <a:cubicBezTo>
                  <a:pt x="449877" y="84573"/>
                  <a:pt x="470783" y="91911"/>
                  <a:pt x="486889" y="103415"/>
                </a:cubicBezTo>
                <a:cubicBezTo>
                  <a:pt x="498503" y="111710"/>
                  <a:pt x="511551" y="118028"/>
                  <a:pt x="522515" y="127165"/>
                </a:cubicBezTo>
                <a:cubicBezTo>
                  <a:pt x="535417" y="137916"/>
                  <a:pt x="544167" y="153475"/>
                  <a:pt x="558141" y="162791"/>
                </a:cubicBezTo>
                <a:cubicBezTo>
                  <a:pt x="568365" y="169607"/>
                  <a:pt x="634930" y="184957"/>
                  <a:pt x="641268" y="186542"/>
                </a:cubicBezTo>
                <a:cubicBezTo>
                  <a:pt x="645226" y="198417"/>
                  <a:pt x="648212" y="210662"/>
                  <a:pt x="653143" y="222168"/>
                </a:cubicBezTo>
                <a:cubicBezTo>
                  <a:pt x="660116" y="238439"/>
                  <a:pt x="683468" y="253232"/>
                  <a:pt x="676894" y="269669"/>
                </a:cubicBezTo>
                <a:cubicBezTo>
                  <a:pt x="670833" y="284823"/>
                  <a:pt x="645086" y="277061"/>
                  <a:pt x="629393" y="281545"/>
                </a:cubicBezTo>
                <a:cubicBezTo>
                  <a:pt x="605407" y="288398"/>
                  <a:pt x="551128" y="308802"/>
                  <a:pt x="534390" y="317171"/>
                </a:cubicBezTo>
                <a:cubicBezTo>
                  <a:pt x="521624" y="323554"/>
                  <a:pt x="510639" y="333004"/>
                  <a:pt x="498764" y="340921"/>
                </a:cubicBezTo>
                <a:cubicBezTo>
                  <a:pt x="490847" y="356755"/>
                  <a:pt x="488613" y="377090"/>
                  <a:pt x="475013" y="388423"/>
                </a:cubicBezTo>
                <a:cubicBezTo>
                  <a:pt x="462475" y="398871"/>
                  <a:pt x="443833" y="400298"/>
                  <a:pt x="427512" y="400298"/>
                </a:cubicBezTo>
                <a:cubicBezTo>
                  <a:pt x="368004" y="400298"/>
                  <a:pt x="308759" y="392381"/>
                  <a:pt x="249382" y="388423"/>
                </a:cubicBezTo>
                <a:cubicBezTo>
                  <a:pt x="229590" y="384464"/>
                  <a:pt x="209673" y="381086"/>
                  <a:pt x="190006" y="376547"/>
                </a:cubicBezTo>
                <a:cubicBezTo>
                  <a:pt x="158200" y="369207"/>
                  <a:pt x="127393" y="356846"/>
                  <a:pt x="95003" y="352797"/>
                </a:cubicBezTo>
                <a:lnTo>
                  <a:pt x="0" y="340921"/>
                </a:lnTo>
                <a:cubicBezTo>
                  <a:pt x="50998" y="302673"/>
                  <a:pt x="47987" y="302386"/>
                  <a:pt x="106878" y="269669"/>
                </a:cubicBezTo>
                <a:cubicBezTo>
                  <a:pt x="122353" y="261072"/>
                  <a:pt x="137804" y="252135"/>
                  <a:pt x="154380" y="245919"/>
                </a:cubicBezTo>
                <a:cubicBezTo>
                  <a:pt x="169662" y="240188"/>
                  <a:pt x="186047" y="238002"/>
                  <a:pt x="201881" y="234043"/>
                </a:cubicBezTo>
                <a:cubicBezTo>
                  <a:pt x="315531" y="120393"/>
                  <a:pt x="180638" y="265908"/>
                  <a:pt x="249382" y="162791"/>
                </a:cubicBezTo>
                <a:cubicBezTo>
                  <a:pt x="258698" y="148817"/>
                  <a:pt x="275246" y="140831"/>
                  <a:pt x="285008" y="127165"/>
                </a:cubicBezTo>
                <a:cubicBezTo>
                  <a:pt x="339797" y="50462"/>
                  <a:pt x="274152" y="102736"/>
                  <a:pt x="344385" y="55913"/>
                </a:cubicBezTo>
                <a:cubicBezTo>
                  <a:pt x="348343" y="44038"/>
                  <a:pt x="348440" y="30062"/>
                  <a:pt x="356260" y="20287"/>
                </a:cubicBezTo>
                <a:cubicBezTo>
                  <a:pt x="380530" y="-10050"/>
                  <a:pt x="413658" y="495"/>
                  <a:pt x="427512" y="8412"/>
                </a:cubicBezTo>
                <a:close/>
              </a:path>
            </a:pathLst>
          </a:custGeom>
          <a:noFill/>
          <a:ln w="76200"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" name="楕円 26">
            <a:extLst>
              <a:ext uri="{FF2B5EF4-FFF2-40B4-BE49-F238E27FC236}">
                <a16:creationId xmlns:a16="http://schemas.microsoft.com/office/drawing/2014/main" id="{E7A0699D-572F-8769-ADD6-45AA9E8D82C5}"/>
              </a:ext>
            </a:extLst>
          </p:cNvPr>
          <p:cNvSpPr/>
          <p:nvPr/>
        </p:nvSpPr>
        <p:spPr>
          <a:xfrm>
            <a:off x="9792530" y="5042748"/>
            <a:ext cx="248017" cy="261258"/>
          </a:xfrm>
          <a:prstGeom prst="ellipse">
            <a:avLst/>
          </a:prstGeom>
          <a:noFill/>
          <a:ln w="38100"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AEFEA13D-53D1-54FF-4F18-AA6C90DFADF2}"/>
              </a:ext>
            </a:extLst>
          </p:cNvPr>
          <p:cNvSpPr txBox="1"/>
          <p:nvPr/>
        </p:nvSpPr>
        <p:spPr>
          <a:xfrm>
            <a:off x="10053787" y="5019489"/>
            <a:ext cx="9605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ar area</a:t>
            </a:r>
            <a:endParaRPr kumimoji="1" lang="ja-JP" altLang="en-US" sz="14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AB3BE9D9-B959-50B0-2127-1948F7474B4B}"/>
              </a:ext>
            </a:extLst>
          </p:cNvPr>
          <p:cNvSpPr txBox="1"/>
          <p:nvPr/>
        </p:nvSpPr>
        <p:spPr>
          <a:xfrm>
            <a:off x="9349442" y="102704"/>
            <a:ext cx="2505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l Figure 2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985A38D8-B7AA-A362-EBF7-9565438178C3}"/>
              </a:ext>
            </a:extLst>
          </p:cNvPr>
          <p:cNvSpPr txBox="1"/>
          <p:nvPr/>
        </p:nvSpPr>
        <p:spPr>
          <a:xfrm>
            <a:off x="3664141" y="5097742"/>
            <a:ext cx="7168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 = 22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6F0B6577-4253-50D2-D669-AFF06C269D8C}"/>
              </a:ext>
            </a:extLst>
          </p:cNvPr>
          <p:cNvSpPr txBox="1"/>
          <p:nvPr/>
        </p:nvSpPr>
        <p:spPr>
          <a:xfrm>
            <a:off x="3661236" y="4816661"/>
            <a:ext cx="7168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 = 18</a:t>
            </a:r>
          </a:p>
        </p:txBody>
      </p:sp>
    </p:spTree>
    <p:extLst>
      <p:ext uri="{BB962C8B-B14F-4D97-AF65-F5344CB8AC3E}">
        <p14:creationId xmlns:p14="http://schemas.microsoft.com/office/powerpoint/2010/main" val="13286958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687</TotalTime>
  <Words>32</Words>
  <Application>Microsoft Office PowerPoint</Application>
  <PresentationFormat>ワイド画面</PresentationFormat>
  <Paragraphs>17</Paragraphs>
  <Slides>1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0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野田 一樹</dc:creator>
  <cp:lastModifiedBy>一樹 野田</cp:lastModifiedBy>
  <cp:revision>83</cp:revision>
  <dcterms:created xsi:type="dcterms:W3CDTF">2023-01-02T05:59:21Z</dcterms:created>
  <dcterms:modified xsi:type="dcterms:W3CDTF">2025-08-03T06:51:35Z</dcterms:modified>
</cp:coreProperties>
</file>